
<file path=[Content_Types].xml><?xml version="1.0" encoding="utf-8"?>
<Types xmlns="http://schemas.openxmlformats.org/package/2006/content-types">
  <Override PartName="/docProps/core.xml" ContentType="application/vnd.openxmlformats-package.core-properties+xml"/>
  <Override PartName="/ppt/slideLayouts/slideLayout6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Default Extension="bin" ContentType="application/vnd.openxmlformats-officedocument.presentationml.printerSettings"/>
  <Default Extension="rels" ContentType="application/vnd.openxmlformats-package.relationships+xml"/>
  <Override PartName="/ppt/tableStyles.xml" ContentType="application/vnd.openxmlformats-officedocument.presentationml.tableStyles+xml"/>
  <Override PartName="/ppt/slideLayouts/slideLayout4.xml" ContentType="application/vnd.openxmlformats-officedocument.presentationml.slideLayout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39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  <p:extLst>
    <p:ext uri="{E76CE94A-603C-4142-B9EB-6D1370010A27}">
      <p14:discardImageEditData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1730" autoAdjust="0"/>
    <p:restoredTop sz="94422" autoAdjust="0"/>
  </p:normalViewPr>
  <p:slideViewPr>
    <p:cSldViewPr snapToGrid="0" snapToObjects="1">
      <p:cViewPr>
        <p:scale>
          <a:sx n="100" d="100"/>
          <a:sy n="100" d="100"/>
        </p:scale>
        <p:origin x="-2592" y="2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8FFB3A-72E6-3D43-969D-A04C47628A69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B302BB-2E67-7E41-9764-F2D4ED767E46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32756400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45991EE-591E-3B44-BC9C-C6A29616BACC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363C0E-BFF9-6E46-B80E-3C4C53626B51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4287755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2"/>
            <a:ext cx="1157288" cy="10401300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6" y="488952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9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8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68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73B7F8-1386-7944-AA2C-22EA271E093D}" type="datetimeFigureOut">
              <a:rPr lang="fr-FR" smtClean="0"/>
              <a:pPr/>
              <a:t>2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E029EF-DA6E-3641-A738-B18D5EB04D1B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152400" y="8318500"/>
            <a:ext cx="51435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dirty="0" smtClean="0">
                <a:latin typeface="Arial"/>
                <a:cs typeface="Arial"/>
              </a:rPr>
              <a:t>Sanchez David </a:t>
            </a:r>
            <a:r>
              <a:rPr lang="en-GB" i="1" dirty="0" smtClean="0">
                <a:latin typeface="Arial"/>
                <a:cs typeface="Arial"/>
              </a:rPr>
              <a:t>et al. </a:t>
            </a:r>
            <a:r>
              <a:rPr lang="en-GB" dirty="0" smtClean="0">
                <a:latin typeface="Arial"/>
                <a:cs typeface="Arial"/>
              </a:rPr>
              <a:t>Supplementary file</a:t>
            </a:r>
            <a:r>
              <a:rPr lang="en-GB" dirty="0" smtClean="0">
                <a:latin typeface="Arial"/>
                <a:cs typeface="Arial"/>
              </a:rPr>
              <a:t> 2 </a:t>
            </a:r>
            <a:endParaRPr lang="en-GB" dirty="0">
              <a:latin typeface="Arial"/>
              <a:cs typeface="Arial"/>
            </a:endParaRPr>
          </a:p>
        </p:txBody>
      </p:sp>
      <p:graphicFrame>
        <p:nvGraphicFramePr>
          <p:cNvPr id="7" name="Tableau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898488895"/>
              </p:ext>
            </p:extLst>
          </p:nvPr>
        </p:nvGraphicFramePr>
        <p:xfrm>
          <a:off x="317500" y="873317"/>
          <a:ext cx="6108700" cy="5368182"/>
        </p:xfrm>
        <a:graphic>
          <a:graphicData uri="http://schemas.openxmlformats.org/drawingml/2006/table">
            <a:tbl>
              <a:tblPr/>
              <a:tblGrid>
                <a:gridCol w="1516260"/>
                <a:gridCol w="4592440"/>
              </a:tblGrid>
              <a:tr h="126811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rimer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equence</a:t>
                      </a:r>
                      <a:endParaRPr lang="fr-FR" sz="9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LGP2_forward_AUG_GW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GGGACAACTTTGTACAAAAAAGTTGGCATGGAGCTTCGGTCCTACC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LGP2_reverse_STOP_GW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GGGACAACTTTGTACAAGAAAGTTGGTTAGTCCAGGGAGAGGTCCG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da5_forward_AUG_GW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GGGACAACTTTGTACAAAAAAGTTGGCATGTCGAATGGGTATTCCACAGACGAG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da5_reverse_STOP_GW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GGGACAACTTTGTACAAGAAAGTTGGTTATAATCCTCATCACTAAATAAAC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igI_fwd_AUG__GW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GGGACAACTTTGTACAAAAAAGTTGGCATGACCACCGAGCAGCGACGC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igI_reverse_STOP__GW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GGGACAACTTTGTACAAGAAAGTTGGTTACATTTGGACATTTCTGCTGG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usBfwd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AAAATATGTGGTTGGAGAGCTCAT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usBrev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CGAGTGAAGATCCCCTTTTTA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HIKV2fwd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TGCACCCAAGTGTACCACAA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HIKV2rev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GCGGTCACAGGCAGTGT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HIKV5fwd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TACAGGTGCTGGCAAACCA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HIKV5rev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CACGCGTCCCTTGTTGT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HIKV6fwd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GGATGACAGCCACGATTG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HIKV6rev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GTCTGCTGGCATGTGGTT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HIKV11fwd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ATGTCATGGGTGCAGAAGATC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HIKV11rev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GCGGCAACAGCAACAAC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N1fwd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CTGTTAGAGGTTGTCCAGAGTGA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N1rev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GCCTCATCCTCCATGTTG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N2fwd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GCGAGAGCTGCCCATCT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N2rev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GACTCCGTTGCAGTGTCAA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N3fwd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GAAGCCAGGGAGAGCTACAGA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N3rev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TGTGCCGGTTGGAAGATG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1fwd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ATGCATCCGGGCTCTCA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1rev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CTGACCATGCTGCCATAGC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1fwd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GAGGAGCAGATGCAAGATAGTAAG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1rev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CGTAAATGCGGAATTCTTGAG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H1fwd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TGAGCTTGATCGGGTTGCTA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H1rev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TTTTATGGATCTCTGCGGTGTAG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7-N1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ttgtaatacgactcactatagggTTAGGGATATCCGAGATGG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7-N2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ttgtaatacgactcactatagggGCTGTTAGAGGTTGTCCAGAGTGA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7-N3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ttgtaatacgactcactatagggGCATGAATTTGCTGGTGAGTTATC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7-N4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ttgtaatacgactcactatagggTGCGAGAGCTGCCCATCT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7-N5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ttgtaatacgactcactatagggAGAAGCCAGGGAGAGCTACAGA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7-P1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ttgtaatacgactcactatagggAATGCATCCGGGCTCTCA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226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7-M1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ttgtaatacgactcactatagggGGAGGAGCAGATGCAAGATAGTAAG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6811"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7-H1</a:t>
                      </a: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ttgtaatacgactcactatagggCTGAGCTTGATCGGGTTGCTA</a:t>
                      </a:r>
                      <a:endParaRPr lang="fr-FR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4091" marR="14091" marT="7926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95430047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90942</TotalTime>
  <Words>98</Words>
  <Application>Microsoft Macintosh PowerPoint</Application>
  <PresentationFormat>Présentation à l'écran (4:3)</PresentationFormat>
  <Paragraphs>75</Paragraphs>
  <Slides>1</Slides>
  <Notes>0</Notes>
  <HiddenSlides>0</HiddenSlides>
  <MMClips>0</MMClips>
  <ScaleCrop>false</ScaleCrop>
  <HeadingPairs>
    <vt:vector size="4" baseType="variant">
      <vt:variant>
        <vt:lpstr>Modèle de conception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IP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Komarova</dc:creator>
  <cp:lastModifiedBy>Administrateur G2V</cp:lastModifiedBy>
  <cp:revision>692</cp:revision>
  <cp:lastPrinted>2016-01-27T13:56:07Z</cp:lastPrinted>
  <dcterms:created xsi:type="dcterms:W3CDTF">2016-02-02T14:16:08Z</dcterms:created>
  <dcterms:modified xsi:type="dcterms:W3CDTF">2016-02-02T14:57:02Z</dcterms:modified>
</cp:coreProperties>
</file>